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F2F2"/>
    <a:srgbClr val="D0CEC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657" autoAdjust="0"/>
    <p:restoredTop sz="96020" autoAdjust="0"/>
  </p:normalViewPr>
  <p:slideViewPr>
    <p:cSldViewPr snapToGrid="0">
      <p:cViewPr varScale="1">
        <p:scale>
          <a:sx n="105" d="100"/>
          <a:sy n="105" d="100"/>
        </p:scale>
        <p:origin x="223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645DD5-110B-4BD5-899C-9A47ECC0EC04}" type="datetimeFigureOut">
              <a:rPr lang="fr-FR" smtClean="0"/>
              <a:t>19/05/2026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32226E-E51C-4047-AEB1-4EF4AF8E03E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01804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32226E-E51C-4047-AEB1-4EF4AF8E03E2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74250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90DAC-C725-4008-8742-8E3763D6D0B6}" type="datetimeFigureOut">
              <a:rPr lang="fr-FR" smtClean="0"/>
              <a:t>19/05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5651C-8E0F-4DB5-B27E-E4EE3314B4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17744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90DAC-C725-4008-8742-8E3763D6D0B6}" type="datetimeFigureOut">
              <a:rPr lang="fr-FR" smtClean="0"/>
              <a:t>19/05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5651C-8E0F-4DB5-B27E-E4EE3314B4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1020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90DAC-C725-4008-8742-8E3763D6D0B6}" type="datetimeFigureOut">
              <a:rPr lang="fr-FR" smtClean="0"/>
              <a:t>19/05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5651C-8E0F-4DB5-B27E-E4EE3314B4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2941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90DAC-C725-4008-8742-8E3763D6D0B6}" type="datetimeFigureOut">
              <a:rPr lang="fr-FR" smtClean="0"/>
              <a:t>19/05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5651C-8E0F-4DB5-B27E-E4EE3314B4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76989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90DAC-C725-4008-8742-8E3763D6D0B6}" type="datetimeFigureOut">
              <a:rPr lang="fr-FR" smtClean="0"/>
              <a:t>19/05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5651C-8E0F-4DB5-B27E-E4EE3314B4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13647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90DAC-C725-4008-8742-8E3763D6D0B6}" type="datetimeFigureOut">
              <a:rPr lang="fr-FR" smtClean="0"/>
              <a:t>19/05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5651C-8E0F-4DB5-B27E-E4EE3314B4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5402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90DAC-C725-4008-8742-8E3763D6D0B6}" type="datetimeFigureOut">
              <a:rPr lang="fr-FR" smtClean="0"/>
              <a:t>19/05/2026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5651C-8E0F-4DB5-B27E-E4EE3314B4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3953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90DAC-C725-4008-8742-8E3763D6D0B6}" type="datetimeFigureOut">
              <a:rPr lang="fr-FR" smtClean="0"/>
              <a:t>19/05/2026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5651C-8E0F-4DB5-B27E-E4EE3314B4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9313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90DAC-C725-4008-8742-8E3763D6D0B6}" type="datetimeFigureOut">
              <a:rPr lang="fr-FR" smtClean="0"/>
              <a:t>19/05/2026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5651C-8E0F-4DB5-B27E-E4EE3314B4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1913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90DAC-C725-4008-8742-8E3763D6D0B6}" type="datetimeFigureOut">
              <a:rPr lang="fr-FR" smtClean="0"/>
              <a:t>19/05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5651C-8E0F-4DB5-B27E-E4EE3314B4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8403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90DAC-C725-4008-8742-8E3763D6D0B6}" type="datetimeFigureOut">
              <a:rPr lang="fr-FR" smtClean="0"/>
              <a:t>19/05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65651C-8E0F-4DB5-B27E-E4EE3314B4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3685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890DAC-C725-4008-8742-8E3763D6D0B6}" type="datetimeFigureOut">
              <a:rPr lang="fr-FR" smtClean="0"/>
              <a:t>19/05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65651C-8E0F-4DB5-B27E-E4EE3314B42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8075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au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35407915"/>
              </p:ext>
            </p:extLst>
          </p:nvPr>
        </p:nvGraphicFramePr>
        <p:xfrm>
          <a:off x="586739" y="540171"/>
          <a:ext cx="8602737" cy="55445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78394">
                  <a:extLst>
                    <a:ext uri="{9D8B030D-6E8A-4147-A177-3AD203B41FA5}">
                      <a16:colId xmlns:a16="http://schemas.microsoft.com/office/drawing/2014/main" val="1884397028"/>
                    </a:ext>
                  </a:extLst>
                </a:gridCol>
                <a:gridCol w="510288">
                  <a:extLst>
                    <a:ext uri="{9D8B030D-6E8A-4147-A177-3AD203B41FA5}">
                      <a16:colId xmlns:a16="http://schemas.microsoft.com/office/drawing/2014/main" val="2607088026"/>
                    </a:ext>
                  </a:extLst>
                </a:gridCol>
                <a:gridCol w="128406">
                  <a:extLst>
                    <a:ext uri="{9D8B030D-6E8A-4147-A177-3AD203B41FA5}">
                      <a16:colId xmlns:a16="http://schemas.microsoft.com/office/drawing/2014/main" val="3446245396"/>
                    </a:ext>
                  </a:extLst>
                </a:gridCol>
                <a:gridCol w="716987">
                  <a:extLst>
                    <a:ext uri="{9D8B030D-6E8A-4147-A177-3AD203B41FA5}">
                      <a16:colId xmlns:a16="http://schemas.microsoft.com/office/drawing/2014/main" val="4277758359"/>
                    </a:ext>
                  </a:extLst>
                </a:gridCol>
                <a:gridCol w="716987">
                  <a:extLst>
                    <a:ext uri="{9D8B030D-6E8A-4147-A177-3AD203B41FA5}">
                      <a16:colId xmlns:a16="http://schemas.microsoft.com/office/drawing/2014/main" val="2469619650"/>
                    </a:ext>
                  </a:extLst>
                </a:gridCol>
                <a:gridCol w="716987">
                  <a:extLst>
                    <a:ext uri="{9D8B030D-6E8A-4147-A177-3AD203B41FA5}">
                      <a16:colId xmlns:a16="http://schemas.microsoft.com/office/drawing/2014/main" val="3624512167"/>
                    </a:ext>
                  </a:extLst>
                </a:gridCol>
                <a:gridCol w="598208">
                  <a:extLst>
                    <a:ext uri="{9D8B030D-6E8A-4147-A177-3AD203B41FA5}">
                      <a16:colId xmlns:a16="http://schemas.microsoft.com/office/drawing/2014/main" val="2792869313"/>
                    </a:ext>
                  </a:extLst>
                </a:gridCol>
                <a:gridCol w="733841">
                  <a:extLst>
                    <a:ext uri="{9D8B030D-6E8A-4147-A177-3AD203B41FA5}">
                      <a16:colId xmlns:a16="http://schemas.microsoft.com/office/drawing/2014/main" val="4027689"/>
                    </a:ext>
                  </a:extLst>
                </a:gridCol>
                <a:gridCol w="163076">
                  <a:extLst>
                    <a:ext uri="{9D8B030D-6E8A-4147-A177-3AD203B41FA5}">
                      <a16:colId xmlns:a16="http://schemas.microsoft.com/office/drawing/2014/main" val="1403024195"/>
                    </a:ext>
                  </a:extLst>
                </a:gridCol>
                <a:gridCol w="1089436">
                  <a:extLst>
                    <a:ext uri="{9D8B030D-6E8A-4147-A177-3AD203B41FA5}">
                      <a16:colId xmlns:a16="http://schemas.microsoft.com/office/drawing/2014/main" val="42005081"/>
                    </a:ext>
                  </a:extLst>
                </a:gridCol>
                <a:gridCol w="931600">
                  <a:extLst>
                    <a:ext uri="{9D8B030D-6E8A-4147-A177-3AD203B41FA5}">
                      <a16:colId xmlns:a16="http://schemas.microsoft.com/office/drawing/2014/main" val="181779939"/>
                    </a:ext>
                  </a:extLst>
                </a:gridCol>
                <a:gridCol w="931600">
                  <a:extLst>
                    <a:ext uri="{9D8B030D-6E8A-4147-A177-3AD203B41FA5}">
                      <a16:colId xmlns:a16="http://schemas.microsoft.com/office/drawing/2014/main" val="990935738"/>
                    </a:ext>
                  </a:extLst>
                </a:gridCol>
                <a:gridCol w="886927">
                  <a:extLst>
                    <a:ext uri="{9D8B030D-6E8A-4147-A177-3AD203B41FA5}">
                      <a16:colId xmlns:a16="http://schemas.microsoft.com/office/drawing/2014/main" val="3081729905"/>
                    </a:ext>
                  </a:extLst>
                </a:gridCol>
              </a:tblGrid>
              <a:tr h="252000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900" b="1" u="none" strike="noStrike" dirty="0">
                          <a:effectLst/>
                        </a:rPr>
                        <a:t>TYR variants</a:t>
                      </a:r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fr-FR" sz="900" b="1" i="1" u="none" strike="noStrike" dirty="0">
                          <a:effectLst/>
                        </a:rPr>
                        <a:t>In silico </a:t>
                      </a:r>
                      <a:r>
                        <a:rPr lang="fr-FR" sz="900" b="1" i="0" u="none" strike="noStrike" dirty="0" err="1">
                          <a:effectLst/>
                        </a:rPr>
                        <a:t>p</a:t>
                      </a:r>
                      <a:r>
                        <a:rPr lang="fr-FR" sz="900" b="1" u="none" strike="noStrike" dirty="0" err="1">
                          <a:effectLst/>
                        </a:rPr>
                        <a:t>redictions</a:t>
                      </a:r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 err="1">
                          <a:effectLst/>
                        </a:rPr>
                        <a:t>GnomAD</a:t>
                      </a:r>
                      <a:r>
                        <a:rPr lang="en-US" sz="900" b="1" u="none" strike="noStrike" dirty="0">
                          <a:effectLst/>
                        </a:rPr>
                        <a:t> allele frequency</a:t>
                      </a:r>
                      <a:br>
                        <a:rPr lang="en-US" sz="900" b="1" u="none" strike="noStrike" dirty="0">
                          <a:effectLst/>
                        </a:rPr>
                      </a:br>
                      <a:r>
                        <a:rPr lang="en-US" sz="900" b="1" u="none" strike="noStrike" dirty="0">
                          <a:effectLst/>
                        </a:rPr>
                        <a:t>(Number HTZ and HMZ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b="1" u="none" strike="noStrike" dirty="0" err="1">
                          <a:effectLst/>
                        </a:rPr>
                        <a:t>ClinVar</a:t>
                      </a:r>
                      <a:r>
                        <a:rPr lang="fr-FR" sz="900" b="1" u="none" strike="noStrike" dirty="0">
                          <a:effectLst/>
                        </a:rPr>
                        <a:t> report and variation ID</a:t>
                      </a:r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MG Classification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900" b="1" u="none" strike="noStrike" dirty="0">
                          <a:effectLst/>
                        </a:rPr>
                        <a:t>Bordeaux </a:t>
                      </a:r>
                      <a:r>
                        <a:rPr lang="fr-FR" sz="900" b="1" u="none" strike="noStrike" dirty="0" err="1">
                          <a:effectLst/>
                        </a:rPr>
                        <a:t>cohort</a:t>
                      </a:r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4602165"/>
                  </a:ext>
                </a:extLst>
              </a:tr>
              <a:tr h="238408"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b="1" u="none" strike="noStrike" dirty="0">
                          <a:effectLst/>
                        </a:rPr>
                        <a:t>c.</a:t>
                      </a:r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900" b="1" u="none" strike="noStrike" dirty="0">
                          <a:effectLst/>
                        </a:rPr>
                        <a:t>p.</a:t>
                      </a:r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1" u="none" strike="noStrike" dirty="0" err="1">
                          <a:effectLst/>
                        </a:rPr>
                        <a:t>Metadome</a:t>
                      </a:r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1" u="none" strike="noStrike" dirty="0" err="1">
                          <a:effectLst/>
                        </a:rPr>
                        <a:t>AlphaMissense</a:t>
                      </a:r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1" u="none" strike="noStrike" dirty="0">
                          <a:effectLst/>
                        </a:rPr>
                        <a:t>Revel</a:t>
                      </a:r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1" u="none" strike="noStrike" dirty="0">
                          <a:effectLst/>
                        </a:rPr>
                        <a:t>CADD </a:t>
                      </a:r>
                      <a:r>
                        <a:rPr lang="fr-FR" sz="900" b="1" u="none" strike="noStrike" dirty="0" err="1">
                          <a:effectLst/>
                        </a:rPr>
                        <a:t>phred</a:t>
                      </a:r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1" u="none" strike="noStrike" dirty="0" err="1">
                          <a:effectLst/>
                        </a:rPr>
                        <a:t>Splicing</a:t>
                      </a:r>
                      <a:br>
                        <a:rPr lang="fr-FR" sz="900" b="1" u="none" strike="noStrike" dirty="0">
                          <a:effectLst/>
                        </a:rPr>
                      </a:br>
                      <a:r>
                        <a:rPr lang="fr-FR" sz="900" b="1" u="none" strike="noStrike" dirty="0" err="1">
                          <a:effectLst/>
                        </a:rPr>
                        <a:t>SpliceAI</a:t>
                      </a:r>
                      <a:r>
                        <a:rPr lang="fr-FR" sz="900" b="1" u="none" strike="noStrike" dirty="0">
                          <a:effectLst/>
                        </a:rPr>
                        <a:t> / </a:t>
                      </a:r>
                      <a:r>
                        <a:rPr lang="fr-FR" sz="900" b="1" u="none" strike="noStrike" dirty="0" err="1">
                          <a:effectLst/>
                        </a:rPr>
                        <a:t>SPiP</a:t>
                      </a:r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1" u="none" strike="noStrike" dirty="0">
                          <a:effectLst/>
                        </a:rPr>
                        <a:t>v4.1.0 (non UKB)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52387695"/>
                  </a:ext>
                </a:extLst>
              </a:tr>
              <a:tr h="55445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u="none" dirty="0"/>
                        <a:t>129G&gt;A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T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R43=</a:t>
                      </a:r>
                    </a:p>
                  </a:txBody>
                  <a:tcPr marL="5815" marR="5815" marT="5815" marB="0" anchor="ctr">
                    <a:lnT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9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T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u="none" strike="noStrike" dirty="0" err="1">
                          <a:effectLst/>
                        </a:rPr>
                        <a:t>Slightly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r>
                        <a:rPr lang="fr-FR" sz="900" u="none" strike="noStrike" dirty="0" err="1">
                          <a:effectLst/>
                        </a:rPr>
                        <a:t>intoleran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T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5815" marR="5815" marT="5815" marB="0" anchor="ctr">
                    <a:lnT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5815" marR="5815" marT="5815" marB="0" anchor="ctr">
                    <a:lnT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6</a:t>
                      </a:r>
                    </a:p>
                  </a:txBody>
                  <a:tcPr marL="5815" marR="5815" marT="5815" marB="0" anchor="ctr">
                    <a:lnT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</a:t>
                      </a:r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ffec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T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T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E-06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1 HTZ-0HMZ)</a:t>
                      </a:r>
                    </a:p>
                  </a:txBody>
                  <a:tcPr marL="5815" marR="5815" marT="5815" marB="0" anchor="ctr">
                    <a:lnT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kely benign </a:t>
                      </a:r>
                      <a:r>
                        <a:rPr lang="fr-GA" sz="900" dirty="0"/>
                        <a:t>208166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T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kely Benign </a:t>
                      </a:r>
                    </a:p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PM2, BP7)</a:t>
                      </a:r>
                    </a:p>
                  </a:txBody>
                  <a:tcPr marL="5815" marR="5815" marT="5815" marB="0" anchor="ctr">
                    <a:lnT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/>
                        <a:t>Found in 1 patient with suspected OCA without a 2</a:t>
                      </a:r>
                      <a:r>
                        <a:rPr lang="en-US" sz="900" baseline="30000" dirty="0"/>
                        <a:t>nd</a:t>
                      </a:r>
                      <a:r>
                        <a:rPr lang="en-US" sz="900" dirty="0"/>
                        <a:t> variant in </a:t>
                      </a:r>
                      <a:r>
                        <a:rPr lang="en-US" sz="900" i="1" dirty="0"/>
                        <a:t>trans</a:t>
                      </a:r>
                    </a:p>
                  </a:txBody>
                  <a:tcPr marL="5815" marR="5815" marT="5815" marB="0" anchor="ctr">
                    <a:lnT w="12700" cap="flat" cmpd="sng" algn="ctr">
                      <a:solidFill>
                        <a:srgbClr val="D0CECE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9131324"/>
                  </a:ext>
                </a:extLst>
              </a:tr>
              <a:tr h="55445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u="none" dirty="0"/>
                        <a:t>346C&gt;T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R116*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9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u="none" strike="noStrike" dirty="0" err="1">
                          <a:effectLst/>
                        </a:rPr>
                        <a:t>Slightly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r>
                        <a:rPr lang="fr-FR" sz="900" u="none" strike="noStrike" dirty="0" err="1">
                          <a:effectLst/>
                        </a:rPr>
                        <a:t>intoleran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.0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</a:t>
                      </a:r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ffec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E-05 (37 HTZ-0HMZ)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hogenic </a:t>
                      </a:r>
                    </a:p>
                    <a:p>
                      <a:pPr algn="ctr" fontAlgn="ctr"/>
                      <a:r>
                        <a:rPr lang="fr-GA" sz="900" dirty="0"/>
                        <a:t>99565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hogenic</a:t>
                      </a:r>
                    </a:p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PVS1, PM2, PP5)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dirty="0"/>
                        <a:t>Found in 11 patients with confirmed OC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9841798"/>
                  </a:ext>
                </a:extLst>
              </a:tr>
              <a:tr h="55445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896G&gt;A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R299H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Slightly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r>
                        <a:rPr lang="fr-FR" sz="900" u="none" strike="noStrike" dirty="0" err="1">
                          <a:effectLst/>
                        </a:rPr>
                        <a:t>toleran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Likely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r>
                        <a:rPr lang="fr-FR" sz="900" u="none" strike="noStrike" dirty="0" err="1">
                          <a:effectLst/>
                        </a:rPr>
                        <a:t>Pathogenic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Damaging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25.9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No </a:t>
                      </a:r>
                      <a:r>
                        <a:rPr lang="fr-FR" sz="900" u="none" strike="noStrike" dirty="0" err="1">
                          <a:effectLst/>
                        </a:rPr>
                        <a:t>effec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E-05</a:t>
                      </a:r>
                      <a:br>
                        <a:rPr lang="fr-FR" sz="900" u="none" strike="noStrike" dirty="0">
                          <a:effectLst/>
                        </a:rPr>
                      </a:br>
                      <a:r>
                        <a:rPr lang="fr-FR" sz="900" u="none" strike="noStrike" dirty="0">
                          <a:effectLst/>
                        </a:rPr>
                        <a:t>(42 HTZ-0 HMZ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Pathogenic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</a:p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3796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hogenic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PM2, PM5, PP3, PP5)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Found in 15 patients with confirmed OCA with 2</a:t>
                      </a:r>
                      <a:r>
                        <a:rPr lang="en-US" sz="900" u="none" strike="noStrike" baseline="30000" dirty="0">
                          <a:effectLst/>
                        </a:rPr>
                        <a:t>nd</a:t>
                      </a:r>
                      <a:r>
                        <a:rPr lang="en-US" sz="900" u="none" strike="noStrike" dirty="0">
                          <a:effectLst/>
                        </a:rPr>
                        <a:t> variant in </a:t>
                      </a:r>
                      <a:r>
                        <a:rPr lang="en-US" sz="900" i="1" u="none" strike="noStrike" dirty="0">
                          <a:effectLst/>
                        </a:rPr>
                        <a:t>trans</a:t>
                      </a:r>
                      <a:r>
                        <a:rPr lang="en-US" sz="900" u="none" strike="noStrike" dirty="0">
                          <a:effectLst/>
                        </a:rPr>
                        <a:t>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0096116"/>
                  </a:ext>
                </a:extLst>
              </a:tr>
              <a:tr h="55445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809C&gt;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S270F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Slightly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r>
                        <a:rPr lang="fr-FR" sz="900" u="none" strike="noStrike" dirty="0" err="1">
                          <a:effectLst/>
                        </a:rPr>
                        <a:t>toleran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Likely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r>
                        <a:rPr lang="fr-FR" sz="900" u="none" strike="noStrike" dirty="0" err="1">
                          <a:effectLst/>
                        </a:rPr>
                        <a:t>Benign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Damaging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26.1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No </a:t>
                      </a:r>
                      <a:r>
                        <a:rPr lang="fr-FR" sz="900" u="none" strike="noStrike" dirty="0" err="1">
                          <a:effectLst/>
                        </a:rPr>
                        <a:t>effec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E-05 (10 HTZ-0 HMZ)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Absen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kely</a:t>
                      </a: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hogenic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PM1, PM2, PP3)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1 patient with multiple carcinomas without OC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0452976"/>
                  </a:ext>
                </a:extLst>
              </a:tr>
              <a:tr h="55445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915C&gt;A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D305E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Toleran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Likely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r>
                        <a:rPr lang="fr-FR" sz="900" u="none" strike="noStrike" dirty="0" err="1">
                          <a:effectLst/>
                        </a:rPr>
                        <a:t>Benign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Damaging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22.4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No </a:t>
                      </a:r>
                      <a:r>
                        <a:rPr lang="fr-FR" sz="900" u="none" strike="noStrike" dirty="0" err="1">
                          <a:effectLst/>
                        </a:rPr>
                        <a:t>effec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E-04</a:t>
                      </a:r>
                      <a:br>
                        <a:rPr lang="fr-FR" sz="900" u="none" strike="noStrike" dirty="0">
                          <a:effectLst/>
                        </a:rPr>
                      </a:br>
                      <a:r>
                        <a:rPr lang="fr-FR" sz="900" u="none" strike="noStrike" dirty="0">
                          <a:effectLst/>
                        </a:rPr>
                        <a:t>(258 HTZ-3 HMZ)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VUS : 8 times</a:t>
                      </a:r>
                      <a:br>
                        <a:rPr lang="en-US" sz="900" u="none" strike="noStrike" dirty="0">
                          <a:effectLst/>
                        </a:rPr>
                      </a:br>
                      <a:r>
                        <a:rPr lang="en-US" sz="900" u="none" strike="noStrike" dirty="0">
                          <a:effectLst/>
                        </a:rPr>
                        <a:t>Likely pathogenic : once 41853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US</a:t>
                      </a:r>
                    </a:p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PM2, PP3, BS3)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Found in 2 patients with suspected OCA without another </a:t>
                      </a:r>
                      <a:r>
                        <a:rPr lang="en-US" sz="900" i="1" u="none" strike="noStrike" dirty="0">
                          <a:effectLst/>
                        </a:rPr>
                        <a:t>TYR</a:t>
                      </a:r>
                      <a:r>
                        <a:rPr lang="en-US" sz="900" u="none" strike="noStrike" dirty="0">
                          <a:effectLst/>
                        </a:rPr>
                        <a:t> varian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8344800"/>
                  </a:ext>
                </a:extLst>
              </a:tr>
              <a:tr h="55445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1171G&gt;A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A391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Intoleran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Likely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r>
                        <a:rPr lang="fr-FR" sz="900" u="none" strike="noStrike" dirty="0" err="1">
                          <a:effectLst/>
                        </a:rPr>
                        <a:t>Benign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Damaging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17.79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No </a:t>
                      </a:r>
                      <a:r>
                        <a:rPr lang="fr-FR" sz="900" u="none" strike="noStrike" dirty="0" err="1">
                          <a:effectLst/>
                        </a:rPr>
                        <a:t>effec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Absen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VUS </a:t>
                      </a:r>
                    </a:p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1465857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US</a:t>
                      </a:r>
                    </a:p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PM2, PP3, BS3)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1 patient </a:t>
                      </a:r>
                      <a:r>
                        <a:rPr lang="fr-FR" sz="900" u="none" strike="noStrike" dirty="0" err="1">
                          <a:effectLst/>
                        </a:rPr>
                        <a:t>without</a:t>
                      </a:r>
                      <a:r>
                        <a:rPr lang="fr-FR" sz="900" u="none" strike="noStrike" dirty="0">
                          <a:effectLst/>
                        </a:rPr>
                        <a:t> OCA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0654490"/>
                  </a:ext>
                </a:extLst>
              </a:tr>
              <a:tr h="55445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575C&gt;A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S192Y</a:t>
                      </a:r>
                      <a:endParaRPr lang="fr-FR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9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Slightly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r>
                        <a:rPr lang="fr-FR" sz="900" u="none" strike="noStrike" dirty="0" err="1">
                          <a:effectLst/>
                        </a:rPr>
                        <a:t>intoleran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Likely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r>
                        <a:rPr lang="fr-FR" sz="900" u="none" strike="noStrike" dirty="0" err="1">
                          <a:effectLst/>
                        </a:rPr>
                        <a:t>Benign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Uncertain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23.8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No </a:t>
                      </a:r>
                      <a:r>
                        <a:rPr lang="fr-FR" sz="900" u="none" strike="noStrike" dirty="0" err="1">
                          <a:effectLst/>
                        </a:rPr>
                        <a:t>effec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E-01</a:t>
                      </a:r>
                      <a:br>
                        <a:rPr lang="de-DE" sz="900" u="none" strike="noStrike" dirty="0">
                          <a:effectLst/>
                        </a:rPr>
                      </a:br>
                      <a:r>
                        <a:rPr lang="de-DE" sz="900" u="none" strike="noStrike" dirty="0">
                          <a:effectLst/>
                        </a:rPr>
                        <a:t>(214009 HTZ-36640 HMZ)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licting classifications of pathogenicity  3778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enign </a:t>
                      </a:r>
                    </a:p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BS1)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Frequently encountered within </a:t>
                      </a:r>
                      <a:r>
                        <a:rPr lang="en-US" sz="900" i="1" u="none" strike="noStrike" dirty="0">
                          <a:effectLst/>
                        </a:rPr>
                        <a:t>TYR</a:t>
                      </a:r>
                      <a:r>
                        <a:rPr lang="en-US" sz="900" u="none" strike="noStrike" dirty="0">
                          <a:effectLst/>
                        </a:rPr>
                        <a:t> haplotype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0029671"/>
                  </a:ext>
                </a:extLst>
              </a:tr>
              <a:tr h="55445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1205G&gt;A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R402Q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Slightly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r>
                        <a:rPr lang="fr-FR" sz="900" u="none" strike="noStrike" dirty="0" err="1">
                          <a:effectLst/>
                        </a:rPr>
                        <a:t>intolerant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Likely</a:t>
                      </a:r>
                      <a:r>
                        <a:rPr lang="fr-FR" sz="900" u="none" strike="noStrike" dirty="0">
                          <a:effectLst/>
                        </a:rPr>
                        <a:t> </a:t>
                      </a:r>
                      <a:r>
                        <a:rPr lang="fr-FR" sz="900" u="none" strike="noStrike" dirty="0" err="1">
                          <a:effectLst/>
                        </a:rPr>
                        <a:t>Benign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 err="1">
                          <a:effectLst/>
                        </a:rPr>
                        <a:t>Damaging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u="none" strike="noStrike" dirty="0">
                          <a:effectLst/>
                        </a:rPr>
                        <a:t>27.2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ESR element alteratio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E-01</a:t>
                      </a:r>
                      <a:br>
                        <a:rPr lang="de-DE" sz="900" u="none" strike="noStrike" dirty="0">
                          <a:effectLst/>
                        </a:rPr>
                      </a:br>
                      <a:r>
                        <a:rPr lang="de-DE" sz="900" u="none" strike="noStrike" dirty="0">
                          <a:effectLst/>
                        </a:rPr>
                        <a:t>(154480 HTZ-19374 HMZ)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flicting classifications of pathogenicity  3779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US</a:t>
                      </a:r>
                    </a:p>
                    <a:p>
                      <a:pPr algn="ctr" fontAlgn="ctr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PP3, BS1)</a:t>
                      </a: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Frequently encountered within </a:t>
                      </a:r>
                      <a:r>
                        <a:rPr lang="en-US" sz="900" i="1" u="none" strike="noStrike" dirty="0">
                          <a:effectLst/>
                        </a:rPr>
                        <a:t>TYR</a:t>
                      </a:r>
                      <a:r>
                        <a:rPr lang="en-US" sz="900" u="none" strike="noStrike" dirty="0">
                          <a:effectLst/>
                        </a:rPr>
                        <a:t> haplotype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15" marR="5815" marT="5815" marB="0" anchor="ctr">
                    <a:lnL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2F2F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99254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1937085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9</TotalTime>
  <Words>338</Words>
  <Application>Microsoft Office PowerPoint</Application>
  <PresentationFormat>Format A4 (210 x 297 mm)</PresentationFormat>
  <Paragraphs>11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Université de Bordeaux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3genu</dc:creator>
  <cp:lastModifiedBy>MICHAUD Vincent</cp:lastModifiedBy>
  <cp:revision>35</cp:revision>
  <dcterms:created xsi:type="dcterms:W3CDTF">2025-06-05T15:17:19Z</dcterms:created>
  <dcterms:modified xsi:type="dcterms:W3CDTF">2026-05-19T14:04:10Z</dcterms:modified>
</cp:coreProperties>
</file>